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23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15" userDrawn="1">
          <p15:clr>
            <a:srgbClr val="A4A3A4"/>
          </p15:clr>
        </p15:guide>
        <p15:guide id="5" orient="horz" pos="3120" userDrawn="1">
          <p15:clr>
            <a:srgbClr val="A4A3A4"/>
          </p15:clr>
        </p15:guide>
        <p15:guide id="7" pos="3439" userDrawn="1">
          <p15:clr>
            <a:srgbClr val="A4A3A4"/>
          </p15:clr>
        </p15:guide>
        <p15:guide id="8" orient="horz" pos="170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249FF"/>
    <a:srgbClr val="FFFE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0589"/>
    <p:restoredTop sz="94444"/>
  </p:normalViewPr>
  <p:slideViewPr>
    <p:cSldViewPr snapToGrid="0" snapToObjects="1">
      <p:cViewPr>
        <p:scale>
          <a:sx n="96" d="100"/>
          <a:sy n="96" d="100"/>
        </p:scale>
        <p:origin x="-344" y="160"/>
      </p:cViewPr>
      <p:guideLst>
        <p:guide orient="horz" pos="5615"/>
        <p:guide orient="horz" pos="3120"/>
        <p:guide pos="3439"/>
        <p:guide orient="horz" pos="170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BC56DB-7ED9-E547-B56C-B88B6FEC3E07}" type="datetimeFigureOut">
              <a:rPr lang="en-US" smtClean="0"/>
              <a:t>3/13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F4B0B5-EE68-F745-8FD0-E985A50751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5445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771DC-BC44-E448-A3B8-F15989FB5E38}" type="datetimeFigureOut">
              <a:rPr lang="en-US" smtClean="0"/>
              <a:t>3/13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4341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8">
            <a:extLst>
              <a:ext uri="{FF2B5EF4-FFF2-40B4-BE49-F238E27FC236}">
                <a16:creationId xmlns:a16="http://schemas.microsoft.com/office/drawing/2014/main" id="{9B4E6A56-1914-BB44-92D2-772C6DE047E1}"/>
              </a:ext>
            </a:extLst>
          </p:cNvPr>
          <p:cNvSpPr txBox="1"/>
          <p:nvPr/>
        </p:nvSpPr>
        <p:spPr>
          <a:xfrm>
            <a:off x="3932880" y="4234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Supplementary Figure 2</a:t>
            </a:r>
          </a:p>
        </p:txBody>
      </p:sp>
      <p:sp>
        <p:nvSpPr>
          <p:cNvPr id="7" name="TextBox 103">
            <a:extLst>
              <a:ext uri="{FF2B5EF4-FFF2-40B4-BE49-F238E27FC236}">
                <a16:creationId xmlns:a16="http://schemas.microsoft.com/office/drawing/2014/main" id="{577226E4-3B1C-684C-9218-DD16F84CBF5D}"/>
              </a:ext>
            </a:extLst>
          </p:cNvPr>
          <p:cNvSpPr txBox="1"/>
          <p:nvPr/>
        </p:nvSpPr>
        <p:spPr>
          <a:xfrm>
            <a:off x="510161" y="574035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/>
              <a:t>A</a:t>
            </a:r>
          </a:p>
        </p:txBody>
      </p:sp>
      <p:sp>
        <p:nvSpPr>
          <p:cNvPr id="8" name="TextBox 283">
            <a:extLst>
              <a:ext uri="{FF2B5EF4-FFF2-40B4-BE49-F238E27FC236}">
                <a16:creationId xmlns:a16="http://schemas.microsoft.com/office/drawing/2014/main" id="{84E97BA2-468F-2B4E-B760-0EE84DC9AD8E}"/>
              </a:ext>
            </a:extLst>
          </p:cNvPr>
          <p:cNvSpPr txBox="1"/>
          <p:nvPr/>
        </p:nvSpPr>
        <p:spPr>
          <a:xfrm>
            <a:off x="4999751" y="574035"/>
            <a:ext cx="3241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/>
              <a:t>B</a:t>
            </a:r>
          </a:p>
        </p:txBody>
      </p:sp>
      <p:pic>
        <p:nvPicPr>
          <p:cNvPr id="9" name="図 4">
            <a:extLst>
              <a:ext uri="{FF2B5EF4-FFF2-40B4-BE49-F238E27FC236}">
                <a16:creationId xmlns:a16="http://schemas.microsoft.com/office/drawing/2014/main" id="{DA69416E-44F6-8B4B-8FEE-B8F5E6D649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1843" y="857358"/>
            <a:ext cx="4163060" cy="2123440"/>
          </a:xfrm>
          <a:prstGeom prst="rect">
            <a:avLst/>
          </a:prstGeom>
        </p:spPr>
      </p:pic>
      <p:sp>
        <p:nvSpPr>
          <p:cNvPr id="11" name="テキスト ボックス 8">
            <a:extLst>
              <a:ext uri="{FF2B5EF4-FFF2-40B4-BE49-F238E27FC236}">
                <a16:creationId xmlns:a16="http://schemas.microsoft.com/office/drawing/2014/main" id="{7EA3AE4E-C357-BC45-97A4-79719CD0A9B8}"/>
              </a:ext>
            </a:extLst>
          </p:cNvPr>
          <p:cNvSpPr txBox="1"/>
          <p:nvPr/>
        </p:nvSpPr>
        <p:spPr>
          <a:xfrm>
            <a:off x="585833" y="3569920"/>
            <a:ext cx="5703586" cy="2092326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Supplementary Figure 2 The influence of Abe and </a:t>
            </a:r>
            <a:r>
              <a:rPr lang="en-US" sz="1400" b="1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Vac</a:t>
            </a: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on autolysosome formation in HeLa cells. </a:t>
            </a:r>
          </a:p>
          <a:p>
            <a:pPr algn="just"/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HeLa cells treated with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DALGreen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were exposed to vehicle (DMSO), 0.25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μ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Abe, 50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n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Vac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, or 100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n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Baf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for 3 hrs. (</a:t>
            </a: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A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) Representative live-cell images stained with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DALGreen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(green) after the drug treatment. Nuclei (blue) were stained with Hoechst 33342. Scale bar: 50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μ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. (</a:t>
            </a: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B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) Means ± S.E.M. (</a:t>
            </a:r>
            <a:r>
              <a:rPr lang="en-US" sz="1400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N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= 3) of relative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DALGreen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signal intensity were calculated from densitometric data of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DALGreen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stained images including at least 61</a:t>
            </a:r>
            <a:r>
              <a:rPr lang="en-US" sz="1400" dirty="0">
                <a:solidFill>
                  <a:srgbClr val="FF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cells. *P &lt; 0.05. Two-tailed unpaired </a:t>
            </a:r>
            <a:r>
              <a:rPr lang="en-US" sz="1400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t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-test.</a:t>
            </a:r>
            <a:endParaRPr lang="ja-JP" sz="1400" kern="100">
              <a:solidFill>
                <a:srgbClr val="FF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9FB7A89-113A-8246-BA9D-DAE48EAA11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11859" y="780494"/>
            <a:ext cx="1511300" cy="248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7998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9404</TotalTime>
  <Words>127</Words>
  <Application>Microsoft Macintosh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MS Mincho</vt:lpstr>
      <vt:lpstr>游明朝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田中 良法</dc:creator>
  <cp:lastModifiedBy>田中 良法</cp:lastModifiedBy>
  <cp:revision>1545</cp:revision>
  <cp:lastPrinted>2022-02-10T10:10:52Z</cp:lastPrinted>
  <dcterms:created xsi:type="dcterms:W3CDTF">2020-08-12T02:53:40Z</dcterms:created>
  <dcterms:modified xsi:type="dcterms:W3CDTF">2024-03-13T03:15:16Z</dcterms:modified>
</cp:coreProperties>
</file>